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2405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osh, Souvik" userId="eecea02d-3ead-4d19-9bc6-c58aca595acd" providerId="ADAL" clId="{69144E3B-363C-4E1E-A419-9FF24181481B}"/>
    <pc:docChg chg="modSld">
      <pc:chgData name="Ghosh, Souvik" userId="eecea02d-3ead-4d19-9bc6-c58aca595acd" providerId="ADAL" clId="{69144E3B-363C-4E1E-A419-9FF24181481B}" dt="2023-01-07T16:28:38.263" v="1" actId="20577"/>
      <pc:docMkLst>
        <pc:docMk/>
      </pc:docMkLst>
      <pc:sldChg chg="modSp mod">
        <pc:chgData name="Ghosh, Souvik" userId="eecea02d-3ead-4d19-9bc6-c58aca595acd" providerId="ADAL" clId="{69144E3B-363C-4E1E-A419-9FF24181481B}" dt="2023-01-07T16:28:38.263" v="1" actId="20577"/>
        <pc:sldMkLst>
          <pc:docMk/>
          <pc:sldMk cId="25223705" sldId="257"/>
        </pc:sldMkLst>
        <pc:spChg chg="mod">
          <ac:chgData name="Ghosh, Souvik" userId="eecea02d-3ead-4d19-9bc6-c58aca595acd" providerId="ADAL" clId="{69144E3B-363C-4E1E-A419-9FF24181481B}" dt="2023-01-07T16:28:38.263" v="1" actId="20577"/>
          <ac:spMkLst>
            <pc:docMk/>
            <pc:sldMk cId="25223705" sldId="257"/>
            <ac:spMk id="4" creationId="{3E16CE02-438D-5F7C-BE1A-414D0F5B2A31}"/>
          </ac:spMkLst>
        </pc:spChg>
      </pc:sldChg>
    </pc:docChg>
  </pc:docChgLst>
  <pc:docChgLst>
    <pc:chgData name="Ghosh, Souvik" userId="eecea02d-3ead-4d19-9bc6-c58aca595acd" providerId="ADAL" clId="{76FE2D08-8DD6-4F83-99EE-A51D3F4667E2}"/>
    <pc:docChg chg="custSel modSld">
      <pc:chgData name="Ghosh, Souvik" userId="eecea02d-3ead-4d19-9bc6-c58aca595acd" providerId="ADAL" clId="{76FE2D08-8DD6-4F83-99EE-A51D3F4667E2}" dt="2022-11-07T11:36:31.845" v="189" actId="114"/>
      <pc:docMkLst>
        <pc:docMk/>
      </pc:docMkLst>
      <pc:sldChg chg="addSp modSp mod">
        <pc:chgData name="Ghosh, Souvik" userId="eecea02d-3ead-4d19-9bc6-c58aca595acd" providerId="ADAL" clId="{76FE2D08-8DD6-4F83-99EE-A51D3F4667E2}" dt="2022-11-07T11:36:31.845" v="189" actId="114"/>
        <pc:sldMkLst>
          <pc:docMk/>
          <pc:sldMk cId="25223705" sldId="257"/>
        </pc:sldMkLst>
        <pc:spChg chg="add mod">
          <ac:chgData name="Ghosh, Souvik" userId="eecea02d-3ead-4d19-9bc6-c58aca595acd" providerId="ADAL" clId="{76FE2D08-8DD6-4F83-99EE-A51D3F4667E2}" dt="2022-11-07T11:36:31.845" v="189" actId="114"/>
          <ac:spMkLst>
            <pc:docMk/>
            <pc:sldMk cId="25223705" sldId="257"/>
            <ac:spMk id="4" creationId="{3E16CE02-438D-5F7C-BE1A-414D0F5B2A31}"/>
          </ac:spMkLst>
        </pc:spChg>
        <pc:picChg chg="mod">
          <ac:chgData name="Ghosh, Souvik" userId="eecea02d-3ead-4d19-9bc6-c58aca595acd" providerId="ADAL" clId="{76FE2D08-8DD6-4F83-99EE-A51D3F4667E2}" dt="2022-10-31T15:20:11.599" v="61" actId="1076"/>
          <ac:picMkLst>
            <pc:docMk/>
            <pc:sldMk cId="25223705" sldId="257"/>
            <ac:picMk id="3" creationId="{084CBB13-7EB1-43EE-8FB3-512C1EEEB35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098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435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10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88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81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995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92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025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75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06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289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2D7CF-965A-4558-9666-23B75B77EB94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6F778D-A773-44BC-BD2C-D1DA78A70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281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84CBB13-7EB1-43EE-8FB3-512C1EEEB3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459" b="67217"/>
          <a:stretch/>
        </p:blipFill>
        <p:spPr>
          <a:xfrm>
            <a:off x="90683" y="1271111"/>
            <a:ext cx="6676634" cy="64352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E16CE02-438D-5F7C-BE1A-414D0F5B2A31}"/>
              </a:ext>
            </a:extLst>
          </p:cNvPr>
          <p:cNvSpPr txBox="1"/>
          <p:nvPr/>
        </p:nvSpPr>
        <p:spPr>
          <a:xfrm>
            <a:off x="181304" y="245360"/>
            <a:ext cx="6353504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1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2. </a:t>
            </a:r>
            <a:r>
              <a:rPr lang="en-US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conserved rolling circle replication motifs (I-yellow; II-red; III-dark blue), superfamily 3 helicase motifs (Walker A- green; B-purple; C-orange) and motifs of unknown function (I-brown; II-black; III-sky blue) were retained in the putative replication-associated proteins (Rep) of the </a:t>
            </a:r>
            <a:r>
              <a:rPr lang="en-US" sz="11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orcine circovirus 3 </a:t>
            </a:r>
            <a:r>
              <a:rPr lang="en-US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PCV3) strains (strain name/year/host species/country/year/GenBank accession number) from the Dominican Republic. Numbers to the right indicate amino acid positions for respective strains.</a:t>
            </a:r>
          </a:p>
        </p:txBody>
      </p:sp>
    </p:spTree>
    <p:extLst>
      <p:ext uri="{BB962C8B-B14F-4D97-AF65-F5344CB8AC3E}">
        <p14:creationId xmlns:p14="http://schemas.microsoft.com/office/powerpoint/2010/main" val="25223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C1558744F9E84F9DB11EE653CC9A55" ma:contentTypeVersion="14" ma:contentTypeDescription="Create a new document." ma:contentTypeScope="" ma:versionID="98c9b13aa71c527b7ced6f332a33a861">
  <xsd:schema xmlns:xsd="http://www.w3.org/2001/XMLSchema" xmlns:xs="http://www.w3.org/2001/XMLSchema" xmlns:p="http://schemas.microsoft.com/office/2006/metadata/properties" xmlns:ns3="84958558-c7aa-4a73-8d7b-4bffe5b377e9" xmlns:ns4="ebe390dc-a215-41b8-b9a7-475ecdd00c54" targetNamespace="http://schemas.microsoft.com/office/2006/metadata/properties" ma:root="true" ma:fieldsID="f478b27cdcb62a09c0a4e554e441f71e" ns3:_="" ns4:_="">
    <xsd:import namespace="84958558-c7aa-4a73-8d7b-4bffe5b377e9"/>
    <xsd:import namespace="ebe390dc-a215-41b8-b9a7-475ecdd00c5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LengthInSeconds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4958558-c7aa-4a73-8d7b-4bffe5b377e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e390dc-a215-41b8-b9a7-475ecdd00c5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8B69FF1-F0C9-4581-8607-ACEA678B826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760C5A0-B8FC-444B-9F42-7992711C55E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4958558-c7aa-4a73-8d7b-4bffe5b377e9"/>
    <ds:schemaRef ds:uri="ebe390dc-a215-41b8-b9a7-475ecdd00c5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F4ACAFB-EA1C-4346-8D75-314B9F909715}">
  <ds:schemaRefs>
    <ds:schemaRef ds:uri="http://purl.org/dc/dcmitype/"/>
    <ds:schemaRef ds:uri="http://purl.org/dc/elements/1.1/"/>
    <ds:schemaRef ds:uri="http://www.w3.org/XML/1998/namespace"/>
    <ds:schemaRef ds:uri="http://schemas.microsoft.com/office/2006/documentManagement/types"/>
    <ds:schemaRef ds:uri="http://purl.org/dc/terms/"/>
    <ds:schemaRef ds:uri="http://schemas.microsoft.com/office/infopath/2007/PartnerControls"/>
    <ds:schemaRef ds:uri="84958558-c7aa-4a73-8d7b-4bffe5b377e9"/>
    <ds:schemaRef ds:uri="http://schemas.openxmlformats.org/package/2006/metadata/core-properties"/>
    <ds:schemaRef ds:uri="ebe390dc-a215-41b8-b9a7-475ecdd00c54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97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inor, Kerry</dc:creator>
  <cp:lastModifiedBy>MDPI</cp:lastModifiedBy>
  <cp:revision>3</cp:revision>
  <dcterms:created xsi:type="dcterms:W3CDTF">2022-10-31T13:40:29Z</dcterms:created>
  <dcterms:modified xsi:type="dcterms:W3CDTF">2023-02-04T07:17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7C1558744F9E84F9DB11EE653CC9A55</vt:lpwstr>
  </property>
</Properties>
</file>